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81004C-52D2-462D-A0DC-15E308C99C2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DB80A9-5DB3-40C0-81E9-FAEF655FC89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086E56-AA79-4E10-A4CA-E59DACE7AB8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C69C01-AC08-47A8-BC6D-4C205CB50CF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AA2EC4-693A-4DC8-8E4D-2F6A8CDB0B2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830F5B-B0E7-4B4B-8A36-B47BC11BBA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FBDA0A-65B2-493D-9308-8DD7ACD4679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CAA05C-CA74-44E0-815E-ABD22C10D3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054CF5-D098-43F0-A76E-32B41A4830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85B2A4-EC66-4E20-8373-4C86B4E690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6826EB-354E-4C23-B52F-826DE66FE4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482A61-8F1E-41CF-BA4A-9EED5877BA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415744C-B613-4C26-B94A-7E347F4E8C44}" type="slidenum">
              <a:rPr b="0" lang="en-CA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656"/>
          <p:cNvSpPr/>
          <p:nvPr/>
        </p:nvSpPr>
        <p:spPr>
          <a:xfrm>
            <a:off x="747360" y="6313320"/>
            <a:ext cx="256284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before trastuzumab-based treatmen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                      </a:t>
            </a: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(patient #5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656"/>
          <p:cNvSpPr/>
          <p:nvPr/>
        </p:nvSpPr>
        <p:spPr>
          <a:xfrm>
            <a:off x="3987720" y="6313320"/>
            <a:ext cx="24606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after trastuzumab-based treatmen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                  </a:t>
            </a: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(patient #5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656"/>
          <p:cNvSpPr/>
          <p:nvPr/>
        </p:nvSpPr>
        <p:spPr>
          <a:xfrm>
            <a:off x="285840" y="3059280"/>
            <a:ext cx="52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H&amp;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656"/>
          <p:cNvSpPr/>
          <p:nvPr/>
        </p:nvSpPr>
        <p:spPr>
          <a:xfrm>
            <a:off x="312840" y="4906800"/>
            <a:ext cx="4856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anti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Irf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656"/>
          <p:cNvSpPr/>
          <p:nvPr/>
        </p:nvSpPr>
        <p:spPr>
          <a:xfrm>
            <a:off x="550800" y="22096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656"/>
          <p:cNvSpPr/>
          <p:nvPr/>
        </p:nvSpPr>
        <p:spPr>
          <a:xfrm>
            <a:off x="3625200" y="21956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656"/>
          <p:cNvSpPr/>
          <p:nvPr/>
        </p:nvSpPr>
        <p:spPr>
          <a:xfrm>
            <a:off x="551520" y="4152960"/>
            <a:ext cx="247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656"/>
          <p:cNvSpPr/>
          <p:nvPr/>
        </p:nvSpPr>
        <p:spPr>
          <a:xfrm>
            <a:off x="3646080" y="41529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12" descr=""/>
          <p:cNvPicPr/>
          <p:nvPr/>
        </p:nvPicPr>
        <p:blipFill>
          <a:blip r:embed="rId1"/>
          <a:stretch/>
        </p:blipFill>
        <p:spPr>
          <a:xfrm>
            <a:off x="855720" y="4356000"/>
            <a:ext cx="2428920" cy="192096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33" descr=""/>
          <p:cNvPicPr/>
          <p:nvPr/>
        </p:nvPicPr>
        <p:blipFill>
          <a:blip r:embed="rId2"/>
          <a:stretch/>
        </p:blipFill>
        <p:spPr>
          <a:xfrm>
            <a:off x="3879720" y="4356000"/>
            <a:ext cx="2428920" cy="191952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18" descr="A picture containing clothing&#10;&#10;Description generated with high confidence"/>
          <p:cNvPicPr/>
          <p:nvPr/>
        </p:nvPicPr>
        <p:blipFill>
          <a:blip r:embed="rId3"/>
          <a:stretch/>
        </p:blipFill>
        <p:spPr>
          <a:xfrm>
            <a:off x="836640" y="2340000"/>
            <a:ext cx="2428920" cy="191916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42" descr=""/>
          <p:cNvPicPr/>
          <p:nvPr/>
        </p:nvPicPr>
        <p:blipFill>
          <a:blip r:embed="rId4"/>
          <a:stretch/>
        </p:blipFill>
        <p:spPr>
          <a:xfrm>
            <a:off x="3860640" y="2340000"/>
            <a:ext cx="2400480" cy="1895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9-19T18:51:13Z</dcterms:created>
  <dc:creator>krosen</dc:creator>
  <dc:description/>
  <dc:language>en-US</dc:language>
  <cp:lastModifiedBy>kirill.rosen@hotmail.com</cp:lastModifiedBy>
  <dcterms:modified xsi:type="dcterms:W3CDTF">2018-10-18T19:31:54Z</dcterms:modified>
  <cp:revision>95</cp:revision>
  <dc:subject/>
  <dc:title>Slide 1</dc:title>
</cp:coreProperties>
</file>